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17" autoAdjust="0"/>
    <p:restoredTop sz="98871" autoAdjust="0"/>
  </p:normalViewPr>
  <p:slideViewPr>
    <p:cSldViewPr snapToGrid="0">
      <p:cViewPr>
        <p:scale>
          <a:sx n="110" d="100"/>
          <a:sy n="110" d="100"/>
        </p:scale>
        <p:origin x="-990" y="-72"/>
      </p:cViewPr>
      <p:guideLst>
        <p:guide orient="horz" pos="2880"/>
        <p:guide pos="2160"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BBF75B7-AFFC-4958-A6F7-46B2BC41DE9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2" rIns="91423" bIns="45712" rtlCol="0" anchor="ctr"/>
          <a:lstStyle/>
          <a:p>
            <a:pPr lvl="0"/>
            <a:endParaRPr lang="en-US" noProof="0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23" tIns="45712" rIns="91423" bIns="45712" rtlCol="0">
            <a:normAutofit/>
          </a:bodyPr>
          <a:lstStyle/>
          <a:p>
            <a:pPr lvl="0"/>
            <a:r>
              <a:rPr lang="fr-FR" noProof="0" smtClean="0"/>
              <a:t>Cliquez pour modifier les styles du texte du masque</a:t>
            </a:r>
          </a:p>
          <a:p>
            <a:pPr lvl="1"/>
            <a:r>
              <a:rPr lang="fr-FR" noProof="0" smtClean="0"/>
              <a:t>Deuxième niveau</a:t>
            </a:r>
          </a:p>
          <a:p>
            <a:pPr lvl="2"/>
            <a:r>
              <a:rPr lang="fr-FR" noProof="0" smtClean="0"/>
              <a:t>Troisième niveau</a:t>
            </a:r>
          </a:p>
          <a:p>
            <a:pPr lvl="3"/>
            <a:r>
              <a:rPr lang="fr-FR" noProof="0" smtClean="0"/>
              <a:t>Quatrième niveau</a:t>
            </a:r>
          </a:p>
          <a:p>
            <a:pPr lvl="4"/>
            <a:r>
              <a:rPr lang="fr-FR" noProof="0" smtClean="0"/>
              <a:t>Cinquième niveau</a:t>
            </a:r>
            <a:endParaRPr lang="en-US" noProof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6EA0D33D-99E7-470B-A863-FEAC81B1F23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 pitchFamily="-123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59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>
              <a:ea typeface="ＭＳ Ｐゴシック"/>
              <a:cs typeface="ＭＳ Ｐゴシック"/>
            </a:endParaRPr>
          </a:p>
        </p:txBody>
      </p:sp>
      <p:sp>
        <p:nvSpPr>
          <p:cNvPr id="37891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33A62443-EEEB-42A2-BD2B-AD0FE419DD9C}" type="slidenum">
              <a:rPr lang="en-US">
                <a:ea typeface="ＭＳ Ｐゴシック" pitchFamily="-123" charset="-128"/>
                <a:cs typeface="ＭＳ Ｐゴシック" pitchFamily="-123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ea typeface="ＭＳ Ｐゴシック" pitchFamily="-123" charset="-128"/>
              <a:cs typeface="ＭＳ Ｐゴシック" pitchFamily="-123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DD8B1-FF3D-4809-A20A-92F27574631B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7D8E77-B1BD-462F-B927-F85B162C8362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7E9C60-AB06-449C-8AEF-53E74FF347B7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05D4E8-7D9B-4F37-90D7-E691D05B29B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205C73-DFD3-4958-B188-E03A983FA9E6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7EA7F1-305B-4AF6-9C57-8C9BEF358C35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F8CDC-1622-4F6F-8E02-DD574598EE29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F3442-A511-4C53-991D-575FF67101A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5CF589-E6E9-401A-B599-0F839CE091B7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5A9A29-AD8F-464B-B80B-AFBAC4469C8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81FB0-F34E-41C1-ACD7-832271379DE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DCCFEE-46BB-4F7A-9520-4DC06B72353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DE034A-FDC7-491F-A568-933EF782C9FE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07C049-9A64-419E-8070-DD90F2C623A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D5D021-C51B-4679-A32B-5EE7BD44BF13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08D0D-8743-43D5-A0C0-DB3A0DC4675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B26C3C-81B3-482A-8BF6-2555E8AA5B3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3AAF8B-F35B-468B-A3A5-99C653F8C27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E85DC9-F4EC-4559-8F1C-5E129D38DDFE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90992B-2DBF-4E87-AC8B-172CD232413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A8A75B-5FB1-46CE-B063-DF3F55D9A43B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890D61-8098-41A9-A6B9-A72005EF5A1D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itle style</a:t>
            </a:r>
            <a:endParaRPr lang="en-US" smtClean="0"/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 smtClean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A90E3A60-F28A-47FA-ACB9-84841312A37C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4E37433D-CAAA-464A-8B14-00BF37462B3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-7727"/>
            <a:ext cx="6857999" cy="553998"/>
          </a:xfrm>
          <a:prstGeom prst="rect">
            <a:avLst/>
          </a:prstGeom>
          <a:noFill/>
        </p:spPr>
        <p:txBody>
          <a:bodyPr wrap="square">
            <a:spAutoFit/>
            <a:scene3d>
              <a:camera prst="orthographicFront"/>
              <a:lightRig rig="balanced" dir="t">
                <a:rot lat="0" lon="0" rev="2100000"/>
              </a:lightRig>
            </a:scene3d>
            <a:sp3d extrusionH="57150" prstMaterial="metal">
              <a:bevelT w="38100" h="25400"/>
              <a:contourClr>
                <a:schemeClr val="bg2"/>
              </a:contourClr>
            </a:sp3d>
          </a:bodyPr>
          <a:lstStyle/>
          <a:p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Table S4. Mapping of LNCR </a:t>
            </a:r>
            <a:r>
              <a:rPr lang="en-GB" sz="1000" b="1" dirty="0" err="1" smtClean="0">
                <a:latin typeface="Times New Roman" pitchFamily="18" charset="0"/>
                <a:cs typeface="Times New Roman" pitchFamily="18" charset="0"/>
              </a:rPr>
              <a:t>rasiRNAs</a:t>
            </a:r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 to genomic regions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000" dirty="0" err="1" smtClean="0">
                <a:latin typeface="Times New Roman" pitchFamily="18" charset="0"/>
                <a:cs typeface="Times New Roman" pitchFamily="18" charset="0"/>
              </a:rPr>
              <a:t>Postion</a:t>
            </a:r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 of the LNCR </a:t>
            </a:r>
            <a:r>
              <a:rPr lang="en-GB" sz="1000" dirty="0" err="1" smtClean="0">
                <a:latin typeface="Times New Roman" pitchFamily="18" charset="0"/>
                <a:cs typeface="Times New Roman" pitchFamily="18" charset="0"/>
              </a:rPr>
              <a:t>rasiRNAs</a:t>
            </a:r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 on some of the </a:t>
            </a:r>
            <a:r>
              <a:rPr lang="en-GB" sz="1000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GB" sz="1000" i="1" dirty="0" err="1" smtClean="0">
                <a:latin typeface="Times New Roman" pitchFamily="18" charset="0"/>
                <a:cs typeface="Times New Roman" pitchFamily="18" charset="0"/>
              </a:rPr>
              <a:t>frugiperda</a:t>
            </a:r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 genomic regions that are cloned in bacterial artificial chromosome (BAC) and sequenced. Only perfect matches are presented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8838" y="6937110"/>
            <a:ext cx="784638" cy="276999"/>
          </a:xfrm>
          <a:prstGeom prst="rect">
            <a:avLst/>
          </a:prstGeom>
          <a:noFill/>
        </p:spPr>
        <p:txBody>
          <a:bodyPr wrap="none">
            <a:spAutoFit/>
            <a:scene3d>
              <a:camera prst="orthographicFront"/>
              <a:lightRig rig="balanced" dir="t">
                <a:rot lat="0" lon="0" rev="2100000"/>
              </a:lightRig>
            </a:scene3d>
            <a:sp3d extrusionH="57150" prstMaterial="metal">
              <a:bevelT w="38100" h="25400"/>
              <a:contourClr>
                <a:schemeClr val="bg2"/>
              </a:contourClr>
            </a:sp3d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200" b="1" dirty="0">
                <a:ln w="50800"/>
                <a:latin typeface="Times New Roman" pitchFamily="18" charset="0"/>
                <a:ea typeface="+mn-ea"/>
                <a:cs typeface="Times New Roman" pitchFamily="18" charset="0"/>
              </a:rPr>
              <a:t>Cluster 2</a:t>
            </a:r>
          </a:p>
        </p:txBody>
      </p:sp>
      <p:sp>
        <p:nvSpPr>
          <p:cNvPr id="6" name="Rectangle 5"/>
          <p:cNvSpPr/>
          <p:nvPr/>
        </p:nvSpPr>
        <p:spPr>
          <a:xfrm>
            <a:off x="267842" y="433417"/>
            <a:ext cx="806631" cy="307777"/>
          </a:xfrm>
          <a:prstGeom prst="rect">
            <a:avLst/>
          </a:prstGeom>
          <a:noFill/>
        </p:spPr>
        <p:txBody>
          <a:bodyPr wrap="none">
            <a:spAutoFit/>
            <a:scene3d>
              <a:camera prst="orthographicFront"/>
              <a:lightRig rig="balanced" dir="t">
                <a:rot lat="0" lon="0" rev="2100000"/>
              </a:lightRig>
            </a:scene3d>
            <a:sp3d extrusionH="57150" prstMaterial="metal">
              <a:bevelT w="38100" h="25400"/>
              <a:contourClr>
                <a:schemeClr val="bg2"/>
              </a:contourClr>
            </a:sp3d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200" b="1" dirty="0">
                <a:ln w="50800"/>
                <a:latin typeface="Times New Roman" pitchFamily="18" charset="0"/>
                <a:ea typeface="+mn-ea"/>
                <a:cs typeface="Times New Roman" pitchFamily="18" charset="0"/>
              </a:rPr>
              <a:t>Cluster</a:t>
            </a:r>
            <a:r>
              <a:rPr lang="fr-FR" sz="1400" b="1" dirty="0">
                <a:ln w="50800"/>
                <a:latin typeface="Times New Roman" pitchFamily="18" charset="0"/>
                <a:ea typeface="+mn-ea"/>
                <a:cs typeface="Times New Roman" pitchFamily="18" charset="0"/>
              </a:rPr>
              <a:t> 1</a:t>
            </a:r>
          </a:p>
        </p:txBody>
      </p:sp>
      <p:graphicFrame>
        <p:nvGraphicFramePr>
          <p:cNvPr id="37484" name="Group 620"/>
          <p:cNvGraphicFramePr>
            <a:graphicFrameLocks noGrp="1"/>
          </p:cNvGraphicFramePr>
          <p:nvPr/>
        </p:nvGraphicFramePr>
        <p:xfrm>
          <a:off x="58738" y="734283"/>
          <a:ext cx="6627812" cy="6223000"/>
        </p:xfrm>
        <a:graphic>
          <a:graphicData uri="http://schemas.openxmlformats.org/drawingml/2006/table">
            <a:tbl>
              <a:tblPr/>
              <a:tblGrid>
                <a:gridCol w="160337"/>
                <a:gridCol w="636803"/>
                <a:gridCol w="645897"/>
                <a:gridCol w="768350"/>
                <a:gridCol w="588963"/>
                <a:gridCol w="625475"/>
                <a:gridCol w="593725"/>
                <a:gridCol w="620712"/>
                <a:gridCol w="638175"/>
                <a:gridCol w="717550"/>
                <a:gridCol w="631825"/>
              </a:tblGrid>
              <a:tr h="3429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LNCR r</a:t>
                      </a:r>
                      <a:r>
                        <a:rPr kumimoji="0" lang="fr-FR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a</a:t>
                      </a:r>
                      <a:r>
                        <a:rPr kumimoji="0" lang="en-US" sz="8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iRN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 ID</a:t>
                      </a:r>
                      <a:endParaRPr kumimoji="0" lang="en-US" sz="8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3A2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3A2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5E0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5E0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4P1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4P1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P1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P1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8P1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9130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3-1013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5459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5-1014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9212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2-1013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0773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64-6529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72-253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36-7930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39-11247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51-1728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5003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1-6530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4-284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5-253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9-7929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46-11248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58-1729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9128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5-6531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8-285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34-3516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1-252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5-7929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50-11248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2-1729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6501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303-6533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329-11036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46-288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62-3519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33-249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45-1011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78-11251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90-1732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7286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300-6533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326-11036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36-250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48-1011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75-11251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87-1732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66134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9-1014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61130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4-1013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5456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3-6530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6-285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3-252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7-7929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48-11248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0-1729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7153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98-6533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324-11035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41-287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57-3519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38-250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50-1011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73-11250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85-1732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0954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7-6531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20-285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36-3517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59-252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3-7928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52-11248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4-1729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9931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68-6530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2-284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8-253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32-7929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43-11247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55-1729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5786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306-6534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332-11036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49-288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65-3520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30-249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42-1010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81-11251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93-1732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0509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2-6530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5-285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4-252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8-7929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47-11248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59-1729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0510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6-1014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9932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80-1014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8525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301-6533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327-11036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44-287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60-3519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35-250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47-1011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76-11251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88-1732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2529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4-6530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7-285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33-3516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2-252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6-7929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49-11248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1-1729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4698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82-1014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7583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2971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94-6532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37-287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53-3518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42-250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69-11250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81-1731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5196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8-1014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9345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81-1014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3185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6-6531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9-285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35-3517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0-252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4-7928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51-11248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3-1729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6434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89-1015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5895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83-1014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08745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305-6534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331-11036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48-288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64-3519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31-249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43-1010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80-11251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92-1732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0955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1-1013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7153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8463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55-6529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281-11031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81-254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45-7931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30-11246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42-1727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5457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0299-11033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9128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5-6530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8-285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34-3516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1-2529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5-7929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50-11248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2-17294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9130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173-1014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7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6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3185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6-6530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9-285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5135-3516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0-252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24-7929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51-112483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63-1729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7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48351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5270-6530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13-2848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566-2531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9330-79295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2445-112480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7257-17292</a:t>
                      </a:r>
                    </a:p>
                  </a:txBody>
                  <a:tcPr marL="3202" marR="3202" marT="3202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37483" name="Group 619"/>
          <p:cNvGraphicFramePr>
            <a:graphicFrameLocks noGrp="1"/>
          </p:cNvGraphicFramePr>
          <p:nvPr/>
        </p:nvGraphicFramePr>
        <p:xfrm>
          <a:off x="58738" y="7194505"/>
          <a:ext cx="6724650" cy="1906588"/>
        </p:xfrm>
        <a:graphic>
          <a:graphicData uri="http://schemas.openxmlformats.org/drawingml/2006/table">
            <a:tbl>
              <a:tblPr/>
              <a:tblGrid>
                <a:gridCol w="150812"/>
                <a:gridCol w="596900"/>
                <a:gridCol w="654050"/>
                <a:gridCol w="682625"/>
                <a:gridCol w="733425"/>
                <a:gridCol w="571500"/>
                <a:gridCol w="342900"/>
                <a:gridCol w="352425"/>
                <a:gridCol w="676275"/>
                <a:gridCol w="628650"/>
                <a:gridCol w="768350"/>
                <a:gridCol w="566738"/>
              </a:tblGrid>
              <a:tr h="30638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LNCR </a:t>
                      </a:r>
                      <a:r>
                        <a:rPr kumimoji="0" lang="en-US" sz="8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rasiRN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 ID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3A2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3A2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3A2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5E0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5E0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4P1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74P1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P1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8P1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-123" charset="0"/>
                        <a:ea typeface="Times New Roman" pitchFamily="-123" charset="0"/>
                        <a:cs typeface="Times New Roman" pitchFamily="-123" charset="0"/>
                      </a:endParaRP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8P14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BAC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04233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64676-64711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98213-9824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09548-109583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81-2116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82-80047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2413-1237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1669-11170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3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04215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16-16651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0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237742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93-212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70-80035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2401-1233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1681-111740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27-16702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1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936377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2398-1233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1684-111735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30-16697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2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413597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91-2136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72-80037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2403-1234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1763-11171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25-1670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3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177726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92-2127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71-80036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2402-12335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11680-11173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26-1670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546380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90-2125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73-8003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24-1669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5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580243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89-212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74-8003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23-16698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46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S</a:t>
                      </a:r>
                      <a:r>
                        <a:rPr kumimoji="0" lang="fr-FR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f_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0605540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2094-2129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80069-80034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x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-123" charset="0"/>
                          <a:ea typeface="Times New Roman" pitchFamily="-123" charset="0"/>
                          <a:cs typeface="Times New Roman" pitchFamily="-123" charset="0"/>
                        </a:rPr>
                        <a:t>16628-16703</a:t>
                      </a:r>
                    </a:p>
                  </a:txBody>
                  <a:tcPr marL="2971" marR="2971" marT="2971" marB="0" anchor="ctr" horzOverflow="overflow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49</TotalTime>
  <Words>700</Words>
  <Application>Microsoft Office PowerPoint</Application>
  <PresentationFormat>Affichage à l'écran (4:3)</PresentationFormat>
  <Paragraphs>559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tanojcic slavica</dc:creator>
  <cp:lastModifiedBy>stanojcic slavica</cp:lastModifiedBy>
  <cp:revision>462</cp:revision>
  <dcterms:created xsi:type="dcterms:W3CDTF">2010-06-16T13:03:54Z</dcterms:created>
  <dcterms:modified xsi:type="dcterms:W3CDTF">2011-07-17T14:51:48Z</dcterms:modified>
</cp:coreProperties>
</file>